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8" r:id="rId2"/>
    <p:sldId id="259" r:id="rId3"/>
    <p:sldId id="261" r:id="rId4"/>
  </p:sldIdLst>
  <p:sldSz cx="12192000" cy="9144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A48FCDD9-BDDB-4BB6-AA62-39EC107FBC31}" v="6" dt="2023-09-26T18:04:17.594"/>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p:scale>
          <a:sx n="400" d="100"/>
          <a:sy n="400" d="100"/>
        </p:scale>
        <p:origin x="-3510" y="-468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10" Type="http://schemas.microsoft.com/office/2015/10/relationships/revisionInfo" Target="revisionInfo.xml"/><Relationship Id="rId4" Type="http://schemas.openxmlformats.org/officeDocument/2006/relationships/slide" Target="slides/slide3.xml"/><Relationship Id="rId9"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George, Paul" userId="9c6e8958-4c77-4b3b-873d-c958bbc66708" providerId="ADAL" clId="{A48FCDD9-BDDB-4BB6-AA62-39EC107FBC31}"/>
    <pc:docChg chg="custSel modSld">
      <pc:chgData name="George, Paul" userId="9c6e8958-4c77-4b3b-873d-c958bbc66708" providerId="ADAL" clId="{A48FCDD9-BDDB-4BB6-AA62-39EC107FBC31}" dt="2023-09-26T18:06:20.669" v="113" actId="20577"/>
      <pc:docMkLst>
        <pc:docMk/>
      </pc:docMkLst>
      <pc:sldChg chg="addSp delSp modSp mod">
        <pc:chgData name="George, Paul" userId="9c6e8958-4c77-4b3b-873d-c958bbc66708" providerId="ADAL" clId="{A48FCDD9-BDDB-4BB6-AA62-39EC107FBC31}" dt="2023-09-26T18:06:20.669" v="113" actId="20577"/>
        <pc:sldMkLst>
          <pc:docMk/>
          <pc:sldMk cId="515257513" sldId="258"/>
        </pc:sldMkLst>
        <pc:spChg chg="mod">
          <ac:chgData name="George, Paul" userId="9c6e8958-4c77-4b3b-873d-c958bbc66708" providerId="ADAL" clId="{A48FCDD9-BDDB-4BB6-AA62-39EC107FBC31}" dt="2023-09-26T18:06:20.669" v="113" actId="20577"/>
          <ac:spMkLst>
            <pc:docMk/>
            <pc:sldMk cId="515257513" sldId="258"/>
            <ac:spMk id="2" creationId="{5CABF5F6-98EC-6F97-42CA-B7446989C909}"/>
          </ac:spMkLst>
        </pc:spChg>
        <pc:picChg chg="del">
          <ac:chgData name="George, Paul" userId="9c6e8958-4c77-4b3b-873d-c958bbc66708" providerId="ADAL" clId="{A48FCDD9-BDDB-4BB6-AA62-39EC107FBC31}" dt="2023-09-26T17:55:35.874" v="0" actId="478"/>
          <ac:picMkLst>
            <pc:docMk/>
            <pc:sldMk cId="515257513" sldId="258"/>
            <ac:picMk id="4" creationId="{386199E7-F77F-DA8A-F84A-ABC1EC43E536}"/>
          </ac:picMkLst>
        </pc:picChg>
        <pc:picChg chg="add mod">
          <ac:chgData name="George, Paul" userId="9c6e8958-4c77-4b3b-873d-c958bbc66708" providerId="ADAL" clId="{A48FCDD9-BDDB-4BB6-AA62-39EC107FBC31}" dt="2023-09-26T17:56:11.302" v="12" actId="1076"/>
          <ac:picMkLst>
            <pc:docMk/>
            <pc:sldMk cId="515257513" sldId="258"/>
            <ac:picMk id="5" creationId="{76444A93-F959-4EE8-6D63-DCF6984B75F0}"/>
          </ac:picMkLst>
        </pc:picChg>
        <pc:picChg chg="add mod">
          <ac:chgData name="George, Paul" userId="9c6e8958-4c77-4b3b-873d-c958bbc66708" providerId="ADAL" clId="{A48FCDD9-BDDB-4BB6-AA62-39EC107FBC31}" dt="2023-09-26T17:56:10.237" v="11" actId="1076"/>
          <ac:picMkLst>
            <pc:docMk/>
            <pc:sldMk cId="515257513" sldId="258"/>
            <ac:picMk id="8" creationId="{96F58E11-4C16-5F7E-2BBE-4F7D9826A257}"/>
          </ac:picMkLst>
        </pc:picChg>
        <pc:picChg chg="del">
          <ac:chgData name="George, Paul" userId="9c6e8958-4c77-4b3b-873d-c958bbc66708" providerId="ADAL" clId="{A48FCDD9-BDDB-4BB6-AA62-39EC107FBC31}" dt="2023-09-26T17:55:37.798" v="1" actId="478"/>
          <ac:picMkLst>
            <pc:docMk/>
            <pc:sldMk cId="515257513" sldId="258"/>
            <ac:picMk id="9" creationId="{8FCFE77F-35A7-9B10-6DB9-48ED109F84FF}"/>
          </ac:picMkLst>
        </pc:picChg>
      </pc:sldChg>
      <pc:sldChg chg="addSp delSp modSp mod">
        <pc:chgData name="George, Paul" userId="9c6e8958-4c77-4b3b-873d-c958bbc66708" providerId="ADAL" clId="{A48FCDD9-BDDB-4BB6-AA62-39EC107FBC31}" dt="2023-09-26T18:03:56.220" v="68" actId="167"/>
        <pc:sldMkLst>
          <pc:docMk/>
          <pc:sldMk cId="3744957167" sldId="259"/>
        </pc:sldMkLst>
        <pc:spChg chg="mod">
          <ac:chgData name="George, Paul" userId="9c6e8958-4c77-4b3b-873d-c958bbc66708" providerId="ADAL" clId="{A48FCDD9-BDDB-4BB6-AA62-39EC107FBC31}" dt="2023-09-26T18:01:58.467" v="65" actId="2711"/>
          <ac:spMkLst>
            <pc:docMk/>
            <pc:sldMk cId="3744957167" sldId="259"/>
            <ac:spMk id="2" creationId="{5CABF5F6-98EC-6F97-42CA-B7446989C909}"/>
          </ac:spMkLst>
        </pc:spChg>
        <pc:picChg chg="add del mod">
          <ac:chgData name="George, Paul" userId="9c6e8958-4c77-4b3b-873d-c958bbc66708" providerId="ADAL" clId="{A48FCDD9-BDDB-4BB6-AA62-39EC107FBC31}" dt="2023-09-26T17:59:23.792" v="15" actId="478"/>
          <ac:picMkLst>
            <pc:docMk/>
            <pc:sldMk cId="3744957167" sldId="259"/>
            <ac:picMk id="3" creationId="{2E3DCF97-4ECB-EF57-9B77-3AB58894E549}"/>
          </ac:picMkLst>
        </pc:picChg>
        <pc:picChg chg="add del mod">
          <ac:chgData name="George, Paul" userId="9c6e8958-4c77-4b3b-873d-c958bbc66708" providerId="ADAL" clId="{A48FCDD9-BDDB-4BB6-AA62-39EC107FBC31}" dt="2023-09-26T17:59:23.792" v="15" actId="478"/>
          <ac:picMkLst>
            <pc:docMk/>
            <pc:sldMk cId="3744957167" sldId="259"/>
            <ac:picMk id="4" creationId="{F771F56B-6598-A8FC-6AEE-E6E888777D4F}"/>
          </ac:picMkLst>
        </pc:picChg>
        <pc:picChg chg="add del mod">
          <ac:chgData name="George, Paul" userId="9c6e8958-4c77-4b3b-873d-c958bbc66708" providerId="ADAL" clId="{A48FCDD9-BDDB-4BB6-AA62-39EC107FBC31}" dt="2023-09-26T17:59:23.792" v="15" actId="478"/>
          <ac:picMkLst>
            <pc:docMk/>
            <pc:sldMk cId="3744957167" sldId="259"/>
            <ac:picMk id="5" creationId="{64748599-C2EE-6447-A173-59A8BF733FD0}"/>
          </ac:picMkLst>
        </pc:picChg>
        <pc:picChg chg="add del mod">
          <ac:chgData name="George, Paul" userId="9c6e8958-4c77-4b3b-873d-c958bbc66708" providerId="ADAL" clId="{A48FCDD9-BDDB-4BB6-AA62-39EC107FBC31}" dt="2023-09-26T17:59:23.792" v="15" actId="478"/>
          <ac:picMkLst>
            <pc:docMk/>
            <pc:sldMk cId="3744957167" sldId="259"/>
            <ac:picMk id="6" creationId="{487D01DF-FBA5-3385-F2A8-D60F5E9380FF}"/>
          </ac:picMkLst>
        </pc:picChg>
        <pc:picChg chg="add del mod">
          <ac:chgData name="George, Paul" userId="9c6e8958-4c77-4b3b-873d-c958bbc66708" providerId="ADAL" clId="{A48FCDD9-BDDB-4BB6-AA62-39EC107FBC31}" dt="2023-09-26T17:59:23.792" v="15" actId="478"/>
          <ac:picMkLst>
            <pc:docMk/>
            <pc:sldMk cId="3744957167" sldId="259"/>
            <ac:picMk id="7" creationId="{9ADF843E-6BB9-FA47-7C2E-B5CFA07C3AE5}"/>
          </ac:picMkLst>
        </pc:picChg>
        <pc:picChg chg="add del mod">
          <ac:chgData name="George, Paul" userId="9c6e8958-4c77-4b3b-873d-c958bbc66708" providerId="ADAL" clId="{A48FCDD9-BDDB-4BB6-AA62-39EC107FBC31}" dt="2023-09-26T17:59:27.160" v="17" actId="478"/>
          <ac:picMkLst>
            <pc:docMk/>
            <pc:sldMk cId="3744957167" sldId="259"/>
            <ac:picMk id="8" creationId="{7EF256F8-E93F-FF58-0D0C-4507ADC5A842}"/>
          </ac:picMkLst>
        </pc:picChg>
        <pc:picChg chg="del">
          <ac:chgData name="George, Paul" userId="9c6e8958-4c77-4b3b-873d-c958bbc66708" providerId="ADAL" clId="{A48FCDD9-BDDB-4BB6-AA62-39EC107FBC31}" dt="2023-09-26T17:59:31.045" v="22" actId="478"/>
          <ac:picMkLst>
            <pc:docMk/>
            <pc:sldMk cId="3744957167" sldId="259"/>
            <ac:picMk id="9" creationId="{A6749919-C587-8A4D-C5D2-F95F08C3A96D}"/>
          </ac:picMkLst>
        </pc:picChg>
        <pc:picChg chg="add del mod">
          <ac:chgData name="George, Paul" userId="9c6e8958-4c77-4b3b-873d-c958bbc66708" providerId="ADAL" clId="{A48FCDD9-BDDB-4BB6-AA62-39EC107FBC31}" dt="2023-09-26T17:59:27.160" v="17" actId="478"/>
          <ac:picMkLst>
            <pc:docMk/>
            <pc:sldMk cId="3744957167" sldId="259"/>
            <ac:picMk id="10" creationId="{CA956C51-ED34-0CBA-884F-B91A0C49B134}"/>
          </ac:picMkLst>
        </pc:picChg>
        <pc:picChg chg="add del mod">
          <ac:chgData name="George, Paul" userId="9c6e8958-4c77-4b3b-873d-c958bbc66708" providerId="ADAL" clId="{A48FCDD9-BDDB-4BB6-AA62-39EC107FBC31}" dt="2023-09-26T17:59:27.160" v="17" actId="478"/>
          <ac:picMkLst>
            <pc:docMk/>
            <pc:sldMk cId="3744957167" sldId="259"/>
            <ac:picMk id="11" creationId="{48A7DC0D-B31A-D697-73AF-D135AA7B4828}"/>
          </ac:picMkLst>
        </pc:picChg>
        <pc:picChg chg="add del mod">
          <ac:chgData name="George, Paul" userId="9c6e8958-4c77-4b3b-873d-c958bbc66708" providerId="ADAL" clId="{A48FCDD9-BDDB-4BB6-AA62-39EC107FBC31}" dt="2023-09-26T17:59:27.160" v="17" actId="478"/>
          <ac:picMkLst>
            <pc:docMk/>
            <pc:sldMk cId="3744957167" sldId="259"/>
            <ac:picMk id="12" creationId="{EE099B6A-FFFE-5AEB-F6C1-6E5524EE6C55}"/>
          </ac:picMkLst>
        </pc:picChg>
        <pc:picChg chg="add del mod">
          <ac:chgData name="George, Paul" userId="9c6e8958-4c77-4b3b-873d-c958bbc66708" providerId="ADAL" clId="{A48FCDD9-BDDB-4BB6-AA62-39EC107FBC31}" dt="2023-09-26T17:59:27.160" v="17" actId="478"/>
          <ac:picMkLst>
            <pc:docMk/>
            <pc:sldMk cId="3744957167" sldId="259"/>
            <ac:picMk id="13" creationId="{F4A0DF5C-F799-E3D4-C66B-3238FEAE9EFF}"/>
          </ac:picMkLst>
        </pc:picChg>
        <pc:picChg chg="add mod ord">
          <ac:chgData name="George, Paul" userId="9c6e8958-4c77-4b3b-873d-c958bbc66708" providerId="ADAL" clId="{A48FCDD9-BDDB-4BB6-AA62-39EC107FBC31}" dt="2023-09-26T18:01:45.478" v="61" actId="166"/>
          <ac:picMkLst>
            <pc:docMk/>
            <pc:sldMk cId="3744957167" sldId="259"/>
            <ac:picMk id="15" creationId="{FB3DF726-F3D5-C849-F6AD-7F9439D25A50}"/>
          </ac:picMkLst>
        </pc:picChg>
        <pc:picChg chg="add mod ord">
          <ac:chgData name="George, Paul" userId="9c6e8958-4c77-4b3b-873d-c958bbc66708" providerId="ADAL" clId="{A48FCDD9-BDDB-4BB6-AA62-39EC107FBC31}" dt="2023-09-26T18:01:45.478" v="61" actId="166"/>
          <ac:picMkLst>
            <pc:docMk/>
            <pc:sldMk cId="3744957167" sldId="259"/>
            <ac:picMk id="17" creationId="{2391D657-4190-25BA-345A-825DD466F0EB}"/>
          </ac:picMkLst>
        </pc:picChg>
        <pc:picChg chg="del">
          <ac:chgData name="George, Paul" userId="9c6e8958-4c77-4b3b-873d-c958bbc66708" providerId="ADAL" clId="{A48FCDD9-BDDB-4BB6-AA62-39EC107FBC31}" dt="2023-09-26T17:59:28.945" v="18" actId="478"/>
          <ac:picMkLst>
            <pc:docMk/>
            <pc:sldMk cId="3744957167" sldId="259"/>
            <ac:picMk id="20" creationId="{295F9CFF-166E-7306-3131-E665A246FF0F}"/>
          </ac:picMkLst>
        </pc:picChg>
        <pc:picChg chg="add mod ord">
          <ac:chgData name="George, Paul" userId="9c6e8958-4c77-4b3b-873d-c958bbc66708" providerId="ADAL" clId="{A48FCDD9-BDDB-4BB6-AA62-39EC107FBC31}" dt="2023-09-26T18:01:45.478" v="61" actId="166"/>
          <ac:picMkLst>
            <pc:docMk/>
            <pc:sldMk cId="3744957167" sldId="259"/>
            <ac:picMk id="21" creationId="{FC9A5426-D1B1-7314-5FDE-D5D12F173F2D}"/>
          </ac:picMkLst>
        </pc:picChg>
        <pc:picChg chg="del">
          <ac:chgData name="George, Paul" userId="9c6e8958-4c77-4b3b-873d-c958bbc66708" providerId="ADAL" clId="{A48FCDD9-BDDB-4BB6-AA62-39EC107FBC31}" dt="2023-09-26T17:59:29.642" v="19" actId="478"/>
          <ac:picMkLst>
            <pc:docMk/>
            <pc:sldMk cId="3744957167" sldId="259"/>
            <ac:picMk id="22" creationId="{8E5E06CD-FF18-4F32-C6A2-B77994F638E8}"/>
          </ac:picMkLst>
        </pc:picChg>
        <pc:picChg chg="del">
          <ac:chgData name="George, Paul" userId="9c6e8958-4c77-4b3b-873d-c958bbc66708" providerId="ADAL" clId="{A48FCDD9-BDDB-4BB6-AA62-39EC107FBC31}" dt="2023-09-26T17:59:23.792" v="15" actId="478"/>
          <ac:picMkLst>
            <pc:docMk/>
            <pc:sldMk cId="3744957167" sldId="259"/>
            <ac:picMk id="24" creationId="{D7BDC707-D5EB-4A9D-C3F8-E93E308C5EA7}"/>
          </ac:picMkLst>
        </pc:picChg>
        <pc:picChg chg="add mod ord">
          <ac:chgData name="George, Paul" userId="9c6e8958-4c77-4b3b-873d-c958bbc66708" providerId="ADAL" clId="{A48FCDD9-BDDB-4BB6-AA62-39EC107FBC31}" dt="2023-09-26T18:01:45.478" v="61" actId="166"/>
          <ac:picMkLst>
            <pc:docMk/>
            <pc:sldMk cId="3744957167" sldId="259"/>
            <ac:picMk id="25" creationId="{566CBEDC-100E-FF3F-D4F0-8465D6AEFC1E}"/>
          </ac:picMkLst>
        </pc:picChg>
        <pc:picChg chg="del">
          <ac:chgData name="George, Paul" userId="9c6e8958-4c77-4b3b-873d-c958bbc66708" providerId="ADAL" clId="{A48FCDD9-BDDB-4BB6-AA62-39EC107FBC31}" dt="2023-09-26T17:59:30.591" v="21" actId="478"/>
          <ac:picMkLst>
            <pc:docMk/>
            <pc:sldMk cId="3744957167" sldId="259"/>
            <ac:picMk id="26" creationId="{C11AE5F0-C942-DF04-FC02-99AA5ABE3928}"/>
          </ac:picMkLst>
        </pc:picChg>
        <pc:picChg chg="del">
          <ac:chgData name="George, Paul" userId="9c6e8958-4c77-4b3b-873d-c958bbc66708" providerId="ADAL" clId="{A48FCDD9-BDDB-4BB6-AA62-39EC107FBC31}" dt="2023-09-26T17:59:30.085" v="20" actId="478"/>
          <ac:picMkLst>
            <pc:docMk/>
            <pc:sldMk cId="3744957167" sldId="259"/>
            <ac:picMk id="28" creationId="{F740D1BC-C46B-8C6D-6A46-8359C9AB5C69}"/>
          </ac:picMkLst>
        </pc:picChg>
        <pc:picChg chg="add mod ord">
          <ac:chgData name="George, Paul" userId="9c6e8958-4c77-4b3b-873d-c958bbc66708" providerId="ADAL" clId="{A48FCDD9-BDDB-4BB6-AA62-39EC107FBC31}" dt="2023-09-26T18:01:45.478" v="61" actId="166"/>
          <ac:picMkLst>
            <pc:docMk/>
            <pc:sldMk cId="3744957167" sldId="259"/>
            <ac:picMk id="29" creationId="{1069D36F-B9B2-E6E0-EF98-EED521FC749C}"/>
          </ac:picMkLst>
        </pc:picChg>
        <pc:picChg chg="add mod ord">
          <ac:chgData name="George, Paul" userId="9c6e8958-4c77-4b3b-873d-c958bbc66708" providerId="ADAL" clId="{A48FCDD9-BDDB-4BB6-AA62-39EC107FBC31}" dt="2023-09-26T18:03:56.220" v="68" actId="167"/>
          <ac:picMkLst>
            <pc:docMk/>
            <pc:sldMk cId="3744957167" sldId="259"/>
            <ac:picMk id="31" creationId="{C1D799F0-3C97-587F-0581-D5A0F9413732}"/>
          </ac:picMkLst>
        </pc:picChg>
      </pc:sldChg>
      <pc:sldChg chg="addSp delSp modSp mod">
        <pc:chgData name="George, Paul" userId="9c6e8958-4c77-4b3b-873d-c958bbc66708" providerId="ADAL" clId="{A48FCDD9-BDDB-4BB6-AA62-39EC107FBC31}" dt="2023-09-26T18:04:55.162" v="83"/>
        <pc:sldMkLst>
          <pc:docMk/>
          <pc:sldMk cId="2639825799" sldId="261"/>
        </pc:sldMkLst>
        <pc:spChg chg="mod">
          <ac:chgData name="George, Paul" userId="9c6e8958-4c77-4b3b-873d-c958bbc66708" providerId="ADAL" clId="{A48FCDD9-BDDB-4BB6-AA62-39EC107FBC31}" dt="2023-09-26T18:04:55.162" v="83"/>
          <ac:spMkLst>
            <pc:docMk/>
            <pc:sldMk cId="2639825799" sldId="261"/>
            <ac:spMk id="2" creationId="{5CABF5F6-98EC-6F97-42CA-B7446989C909}"/>
          </ac:spMkLst>
        </pc:spChg>
        <pc:spChg chg="mod">
          <ac:chgData name="George, Paul" userId="9c6e8958-4c77-4b3b-873d-c958bbc66708" providerId="ADAL" clId="{A48FCDD9-BDDB-4BB6-AA62-39EC107FBC31}" dt="2023-09-26T18:04:32.939" v="80" actId="1076"/>
          <ac:spMkLst>
            <pc:docMk/>
            <pc:sldMk cId="2639825799" sldId="261"/>
            <ac:spMk id="19" creationId="{8647C4DA-ABF3-1B74-8C36-5E500B94E9AC}"/>
          </ac:spMkLst>
        </pc:spChg>
        <pc:picChg chg="add mod">
          <ac:chgData name="George, Paul" userId="9c6e8958-4c77-4b3b-873d-c958bbc66708" providerId="ADAL" clId="{A48FCDD9-BDDB-4BB6-AA62-39EC107FBC31}" dt="2023-09-26T18:04:24.282" v="77" actId="1076"/>
          <ac:picMkLst>
            <pc:docMk/>
            <pc:sldMk cId="2639825799" sldId="261"/>
            <ac:picMk id="4" creationId="{3A3A974E-EEE5-47EF-AEFC-3CD652E63D29}"/>
          </ac:picMkLst>
        </pc:picChg>
        <pc:picChg chg="del">
          <ac:chgData name="George, Paul" userId="9c6e8958-4c77-4b3b-873d-c958bbc66708" providerId="ADAL" clId="{A48FCDD9-BDDB-4BB6-AA62-39EC107FBC31}" dt="2023-09-26T18:04:01.165" v="69" actId="478"/>
          <ac:picMkLst>
            <pc:docMk/>
            <pc:sldMk cId="2639825799" sldId="261"/>
            <ac:picMk id="5" creationId="{41562809-3F35-65E2-515A-2DA48A293CA4}"/>
          </ac:picMkLst>
        </pc:picChg>
        <pc:picChg chg="del">
          <ac:chgData name="George, Paul" userId="9c6e8958-4c77-4b3b-873d-c958bbc66708" providerId="ADAL" clId="{A48FCDD9-BDDB-4BB6-AA62-39EC107FBC31}" dt="2023-09-26T18:04:01.165" v="69" actId="478"/>
          <ac:picMkLst>
            <pc:docMk/>
            <pc:sldMk cId="2639825799" sldId="261"/>
            <ac:picMk id="8" creationId="{5F31D197-3B03-E5B2-FED2-7E194DC80C7F}"/>
          </ac:picMkLst>
        </pc:picChg>
        <pc:picChg chg="add mod">
          <ac:chgData name="George, Paul" userId="9c6e8958-4c77-4b3b-873d-c958bbc66708" providerId="ADAL" clId="{A48FCDD9-BDDB-4BB6-AA62-39EC107FBC31}" dt="2023-09-26T18:04:28.976" v="78" actId="1076"/>
          <ac:picMkLst>
            <pc:docMk/>
            <pc:sldMk cId="2639825799" sldId="261"/>
            <ac:picMk id="9" creationId="{35262679-9CB6-F31D-DC66-344EF2F3D779}"/>
          </ac:picMkLst>
        </pc:pic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1496484"/>
            <a:ext cx="10363200" cy="3183467"/>
          </a:xfrm>
        </p:spPr>
        <p:txBody>
          <a:bodyPr anchor="b"/>
          <a:lstStyle>
            <a:lvl1pPr algn="ctr">
              <a:defRPr sz="8000"/>
            </a:lvl1pPr>
          </a:lstStyle>
          <a:p>
            <a:r>
              <a:rPr lang="en-US"/>
              <a:t>Click to edit Master title style</a:t>
            </a:r>
            <a:endParaRPr lang="en-US" dirty="0"/>
          </a:p>
        </p:txBody>
      </p:sp>
      <p:sp>
        <p:nvSpPr>
          <p:cNvPr id="3" name="Subtitle 2"/>
          <p:cNvSpPr>
            <a:spLocks noGrp="1"/>
          </p:cNvSpPr>
          <p:nvPr>
            <p:ph type="subTitle" idx="1"/>
          </p:nvPr>
        </p:nvSpPr>
        <p:spPr>
          <a:xfrm>
            <a:off x="1524000" y="4802717"/>
            <a:ext cx="9144000" cy="2207683"/>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E30471E4-1CAE-48BA-8DD1-3927B43C0910}" type="datetimeFigureOut">
              <a:rPr lang="en-US" smtClean="0"/>
              <a:t>9/2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B9793E1-9EC7-453E-B1CC-F24D0D75A1B2}" type="slidenum">
              <a:rPr lang="en-US" smtClean="0"/>
              <a:t>‹#›</a:t>
            </a:fld>
            <a:endParaRPr lang="en-US"/>
          </a:p>
        </p:txBody>
      </p:sp>
    </p:spTree>
    <p:extLst>
      <p:ext uri="{BB962C8B-B14F-4D97-AF65-F5344CB8AC3E}">
        <p14:creationId xmlns:p14="http://schemas.microsoft.com/office/powerpoint/2010/main" val="371926598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30471E4-1CAE-48BA-8DD1-3927B43C0910}" type="datetimeFigureOut">
              <a:rPr lang="en-US" smtClean="0"/>
              <a:t>9/2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B9793E1-9EC7-453E-B1CC-F24D0D75A1B2}" type="slidenum">
              <a:rPr lang="en-US" smtClean="0"/>
              <a:t>‹#›</a:t>
            </a:fld>
            <a:endParaRPr lang="en-US"/>
          </a:p>
        </p:txBody>
      </p:sp>
    </p:spTree>
    <p:extLst>
      <p:ext uri="{BB962C8B-B14F-4D97-AF65-F5344CB8AC3E}">
        <p14:creationId xmlns:p14="http://schemas.microsoft.com/office/powerpoint/2010/main" val="80547070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486834"/>
            <a:ext cx="2628900"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1" y="486834"/>
            <a:ext cx="7734300"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30471E4-1CAE-48BA-8DD1-3927B43C0910}" type="datetimeFigureOut">
              <a:rPr lang="en-US" smtClean="0"/>
              <a:t>9/2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B9793E1-9EC7-453E-B1CC-F24D0D75A1B2}" type="slidenum">
              <a:rPr lang="en-US" smtClean="0"/>
              <a:t>‹#›</a:t>
            </a:fld>
            <a:endParaRPr lang="en-US"/>
          </a:p>
        </p:txBody>
      </p:sp>
    </p:spTree>
    <p:extLst>
      <p:ext uri="{BB962C8B-B14F-4D97-AF65-F5344CB8AC3E}">
        <p14:creationId xmlns:p14="http://schemas.microsoft.com/office/powerpoint/2010/main" val="73948767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30471E4-1CAE-48BA-8DD1-3927B43C0910}" type="datetimeFigureOut">
              <a:rPr lang="en-US" smtClean="0"/>
              <a:t>9/2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B9793E1-9EC7-453E-B1CC-F24D0D75A1B2}" type="slidenum">
              <a:rPr lang="en-US" smtClean="0"/>
              <a:t>‹#›</a:t>
            </a:fld>
            <a:endParaRPr lang="en-US"/>
          </a:p>
        </p:txBody>
      </p:sp>
    </p:spTree>
    <p:extLst>
      <p:ext uri="{BB962C8B-B14F-4D97-AF65-F5344CB8AC3E}">
        <p14:creationId xmlns:p14="http://schemas.microsoft.com/office/powerpoint/2010/main" val="12975905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2279653"/>
            <a:ext cx="10515600" cy="3803649"/>
          </a:xfrm>
        </p:spPr>
        <p:txBody>
          <a:bodyPr anchor="b"/>
          <a:lstStyle>
            <a:lvl1pPr>
              <a:defRPr sz="8000"/>
            </a:lvl1pPr>
          </a:lstStyle>
          <a:p>
            <a:r>
              <a:rPr lang="en-US"/>
              <a:t>Click to edit Master title style</a:t>
            </a:r>
            <a:endParaRPr lang="en-US" dirty="0"/>
          </a:p>
        </p:txBody>
      </p:sp>
      <p:sp>
        <p:nvSpPr>
          <p:cNvPr id="3" name="Text Placeholder 2"/>
          <p:cNvSpPr>
            <a:spLocks noGrp="1"/>
          </p:cNvSpPr>
          <p:nvPr>
            <p:ph type="body" idx="1"/>
          </p:nvPr>
        </p:nvSpPr>
        <p:spPr>
          <a:xfrm>
            <a:off x="831851" y="6119286"/>
            <a:ext cx="10515600" cy="2000249"/>
          </a:xfrm>
        </p:spPr>
        <p:txBody>
          <a:bodyPr/>
          <a:lstStyle>
            <a:lvl1pPr marL="0" indent="0">
              <a:buNone/>
              <a:defRPr sz="3200">
                <a:solidFill>
                  <a:schemeClr val="tx1"/>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E30471E4-1CAE-48BA-8DD1-3927B43C0910}" type="datetimeFigureOut">
              <a:rPr lang="en-US" smtClean="0"/>
              <a:t>9/26/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B9793E1-9EC7-453E-B1CC-F24D0D75A1B2}" type="slidenum">
              <a:rPr lang="en-US" smtClean="0"/>
              <a:t>‹#›</a:t>
            </a:fld>
            <a:endParaRPr lang="en-US"/>
          </a:p>
        </p:txBody>
      </p:sp>
    </p:spTree>
    <p:extLst>
      <p:ext uri="{BB962C8B-B14F-4D97-AF65-F5344CB8AC3E}">
        <p14:creationId xmlns:p14="http://schemas.microsoft.com/office/powerpoint/2010/main" val="162749657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2434167"/>
            <a:ext cx="518160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2434167"/>
            <a:ext cx="518160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E30471E4-1CAE-48BA-8DD1-3927B43C0910}" type="datetimeFigureOut">
              <a:rPr lang="en-US" smtClean="0"/>
              <a:t>9/26/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B9793E1-9EC7-453E-B1CC-F24D0D75A1B2}" type="slidenum">
              <a:rPr lang="en-US" smtClean="0"/>
              <a:t>‹#›</a:t>
            </a:fld>
            <a:endParaRPr lang="en-US"/>
          </a:p>
        </p:txBody>
      </p:sp>
    </p:spTree>
    <p:extLst>
      <p:ext uri="{BB962C8B-B14F-4D97-AF65-F5344CB8AC3E}">
        <p14:creationId xmlns:p14="http://schemas.microsoft.com/office/powerpoint/2010/main" val="210890756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486836"/>
            <a:ext cx="10515600"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9" y="2241551"/>
            <a:ext cx="5157787" cy="1098549"/>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4" name="Content Placeholder 3"/>
          <p:cNvSpPr>
            <a:spLocks noGrp="1"/>
          </p:cNvSpPr>
          <p:nvPr>
            <p:ph sz="half" idx="2"/>
          </p:nvPr>
        </p:nvSpPr>
        <p:spPr>
          <a:xfrm>
            <a:off x="839789" y="3340100"/>
            <a:ext cx="5157787"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1" y="2241551"/>
            <a:ext cx="5183188" cy="1098549"/>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6" name="Content Placeholder 5"/>
          <p:cNvSpPr>
            <a:spLocks noGrp="1"/>
          </p:cNvSpPr>
          <p:nvPr>
            <p:ph sz="quarter" idx="4"/>
          </p:nvPr>
        </p:nvSpPr>
        <p:spPr>
          <a:xfrm>
            <a:off x="6172201" y="3340100"/>
            <a:ext cx="5183188"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E30471E4-1CAE-48BA-8DD1-3927B43C0910}" type="datetimeFigureOut">
              <a:rPr lang="en-US" smtClean="0"/>
              <a:t>9/26/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B9793E1-9EC7-453E-B1CC-F24D0D75A1B2}" type="slidenum">
              <a:rPr lang="en-US" smtClean="0"/>
              <a:t>‹#›</a:t>
            </a:fld>
            <a:endParaRPr lang="en-US"/>
          </a:p>
        </p:txBody>
      </p:sp>
    </p:spTree>
    <p:extLst>
      <p:ext uri="{BB962C8B-B14F-4D97-AF65-F5344CB8AC3E}">
        <p14:creationId xmlns:p14="http://schemas.microsoft.com/office/powerpoint/2010/main" val="3352661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E30471E4-1CAE-48BA-8DD1-3927B43C0910}" type="datetimeFigureOut">
              <a:rPr lang="en-US" smtClean="0"/>
              <a:t>9/26/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B9793E1-9EC7-453E-B1CC-F24D0D75A1B2}" type="slidenum">
              <a:rPr lang="en-US" smtClean="0"/>
              <a:t>‹#›</a:t>
            </a:fld>
            <a:endParaRPr lang="en-US"/>
          </a:p>
        </p:txBody>
      </p:sp>
    </p:spTree>
    <p:extLst>
      <p:ext uri="{BB962C8B-B14F-4D97-AF65-F5344CB8AC3E}">
        <p14:creationId xmlns:p14="http://schemas.microsoft.com/office/powerpoint/2010/main" val="206278995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30471E4-1CAE-48BA-8DD1-3927B43C0910}" type="datetimeFigureOut">
              <a:rPr lang="en-US" smtClean="0"/>
              <a:t>9/26/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B9793E1-9EC7-453E-B1CC-F24D0D75A1B2}" type="slidenum">
              <a:rPr lang="en-US" smtClean="0"/>
              <a:t>‹#›</a:t>
            </a:fld>
            <a:endParaRPr lang="en-US"/>
          </a:p>
        </p:txBody>
      </p:sp>
    </p:spTree>
    <p:extLst>
      <p:ext uri="{BB962C8B-B14F-4D97-AF65-F5344CB8AC3E}">
        <p14:creationId xmlns:p14="http://schemas.microsoft.com/office/powerpoint/2010/main" val="383546151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609600"/>
            <a:ext cx="3932237" cy="2133600"/>
          </a:xfrm>
        </p:spPr>
        <p:txBody>
          <a:bodyPr anchor="b"/>
          <a:lstStyle>
            <a:lvl1pPr>
              <a:defRPr sz="4267"/>
            </a:lvl1pPr>
          </a:lstStyle>
          <a:p>
            <a:r>
              <a:rPr lang="en-US"/>
              <a:t>Click to edit Master title style</a:t>
            </a:r>
            <a:endParaRPr lang="en-US" dirty="0"/>
          </a:p>
        </p:txBody>
      </p:sp>
      <p:sp>
        <p:nvSpPr>
          <p:cNvPr id="3" name="Content Placeholder 2"/>
          <p:cNvSpPr>
            <a:spLocks noGrp="1"/>
          </p:cNvSpPr>
          <p:nvPr>
            <p:ph idx="1"/>
          </p:nvPr>
        </p:nvSpPr>
        <p:spPr>
          <a:xfrm>
            <a:off x="5183188" y="1316569"/>
            <a:ext cx="6172200" cy="6498167"/>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743200"/>
            <a:ext cx="3932237" cy="5082117"/>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p:cNvSpPr>
            <a:spLocks noGrp="1"/>
          </p:cNvSpPr>
          <p:nvPr>
            <p:ph type="dt" sz="half" idx="10"/>
          </p:nvPr>
        </p:nvSpPr>
        <p:spPr/>
        <p:txBody>
          <a:bodyPr/>
          <a:lstStyle/>
          <a:p>
            <a:fld id="{E30471E4-1CAE-48BA-8DD1-3927B43C0910}" type="datetimeFigureOut">
              <a:rPr lang="en-US" smtClean="0"/>
              <a:t>9/26/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B9793E1-9EC7-453E-B1CC-F24D0D75A1B2}" type="slidenum">
              <a:rPr lang="en-US" smtClean="0"/>
              <a:t>‹#›</a:t>
            </a:fld>
            <a:endParaRPr lang="en-US"/>
          </a:p>
        </p:txBody>
      </p:sp>
    </p:spTree>
    <p:extLst>
      <p:ext uri="{BB962C8B-B14F-4D97-AF65-F5344CB8AC3E}">
        <p14:creationId xmlns:p14="http://schemas.microsoft.com/office/powerpoint/2010/main" val="221426917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609600"/>
            <a:ext cx="3932237" cy="2133600"/>
          </a:xfrm>
        </p:spPr>
        <p:txBody>
          <a:bodyPr anchor="b"/>
          <a:lstStyle>
            <a:lvl1pPr>
              <a:defRPr sz="4267"/>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1316569"/>
            <a:ext cx="6172200" cy="6498167"/>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en-US"/>
              <a:t>Click icon to add picture</a:t>
            </a:r>
            <a:endParaRPr lang="en-US" dirty="0"/>
          </a:p>
        </p:txBody>
      </p:sp>
      <p:sp>
        <p:nvSpPr>
          <p:cNvPr id="4" name="Text Placeholder 3"/>
          <p:cNvSpPr>
            <a:spLocks noGrp="1"/>
          </p:cNvSpPr>
          <p:nvPr>
            <p:ph type="body" sz="half" idx="2"/>
          </p:nvPr>
        </p:nvSpPr>
        <p:spPr>
          <a:xfrm>
            <a:off x="839788" y="2743200"/>
            <a:ext cx="3932237" cy="5082117"/>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p:cNvSpPr>
            <a:spLocks noGrp="1"/>
          </p:cNvSpPr>
          <p:nvPr>
            <p:ph type="dt" sz="half" idx="10"/>
          </p:nvPr>
        </p:nvSpPr>
        <p:spPr/>
        <p:txBody>
          <a:bodyPr/>
          <a:lstStyle/>
          <a:p>
            <a:fld id="{E30471E4-1CAE-48BA-8DD1-3927B43C0910}" type="datetimeFigureOut">
              <a:rPr lang="en-US" smtClean="0"/>
              <a:t>9/26/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B9793E1-9EC7-453E-B1CC-F24D0D75A1B2}" type="slidenum">
              <a:rPr lang="en-US" smtClean="0"/>
              <a:t>‹#›</a:t>
            </a:fld>
            <a:endParaRPr lang="en-US"/>
          </a:p>
        </p:txBody>
      </p:sp>
    </p:spTree>
    <p:extLst>
      <p:ext uri="{BB962C8B-B14F-4D97-AF65-F5344CB8AC3E}">
        <p14:creationId xmlns:p14="http://schemas.microsoft.com/office/powerpoint/2010/main" val="61044545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486836"/>
            <a:ext cx="10515600"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2434167"/>
            <a:ext cx="10515600"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8475136"/>
            <a:ext cx="2743200" cy="486833"/>
          </a:xfrm>
          <a:prstGeom prst="rect">
            <a:avLst/>
          </a:prstGeom>
        </p:spPr>
        <p:txBody>
          <a:bodyPr vert="horz" lIns="91440" tIns="45720" rIns="91440" bIns="45720" rtlCol="0" anchor="ctr"/>
          <a:lstStyle>
            <a:lvl1pPr algn="l">
              <a:defRPr sz="1600">
                <a:solidFill>
                  <a:schemeClr val="tx1">
                    <a:tint val="75000"/>
                  </a:schemeClr>
                </a:solidFill>
              </a:defRPr>
            </a:lvl1pPr>
          </a:lstStyle>
          <a:p>
            <a:fld id="{E30471E4-1CAE-48BA-8DD1-3927B43C0910}" type="datetimeFigureOut">
              <a:rPr lang="en-US" smtClean="0"/>
              <a:t>9/26/2023</a:t>
            </a:fld>
            <a:endParaRPr lang="en-US"/>
          </a:p>
        </p:txBody>
      </p:sp>
      <p:sp>
        <p:nvSpPr>
          <p:cNvPr id="5" name="Footer Placeholder 4"/>
          <p:cNvSpPr>
            <a:spLocks noGrp="1"/>
          </p:cNvSpPr>
          <p:nvPr>
            <p:ph type="ftr" sz="quarter" idx="3"/>
          </p:nvPr>
        </p:nvSpPr>
        <p:spPr>
          <a:xfrm>
            <a:off x="4038600" y="8475136"/>
            <a:ext cx="4114800" cy="486833"/>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8475136"/>
            <a:ext cx="2743200" cy="486833"/>
          </a:xfrm>
          <a:prstGeom prst="rect">
            <a:avLst/>
          </a:prstGeom>
        </p:spPr>
        <p:txBody>
          <a:bodyPr vert="horz" lIns="91440" tIns="45720" rIns="91440" bIns="45720" rtlCol="0" anchor="ctr"/>
          <a:lstStyle>
            <a:lvl1pPr algn="r">
              <a:defRPr sz="1600">
                <a:solidFill>
                  <a:schemeClr val="tx1">
                    <a:tint val="75000"/>
                  </a:schemeClr>
                </a:solidFill>
              </a:defRPr>
            </a:lvl1pPr>
          </a:lstStyle>
          <a:p>
            <a:fld id="{CB9793E1-9EC7-453E-B1CC-F24D0D75A1B2}" type="slidenum">
              <a:rPr lang="en-US" smtClean="0"/>
              <a:t>‹#›</a:t>
            </a:fld>
            <a:endParaRPr lang="en-US"/>
          </a:p>
        </p:txBody>
      </p:sp>
    </p:spTree>
    <p:extLst>
      <p:ext uri="{BB962C8B-B14F-4D97-AF65-F5344CB8AC3E}">
        <p14:creationId xmlns:p14="http://schemas.microsoft.com/office/powerpoint/2010/main" val="30438036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7" Type="http://schemas.openxmlformats.org/officeDocument/2006/relationships/image" Target="../media/image8.png"/><Relationship Id="rId2" Type="http://schemas.openxmlformats.org/officeDocument/2006/relationships/image" Target="../media/image3.png"/><Relationship Id="rId1" Type="http://schemas.openxmlformats.org/officeDocument/2006/relationships/slideLayout" Target="../slideLayouts/slideLayout2.xml"/><Relationship Id="rId6" Type="http://schemas.openxmlformats.org/officeDocument/2006/relationships/image" Target="../media/image7.png"/><Relationship Id="rId5" Type="http://schemas.openxmlformats.org/officeDocument/2006/relationships/image" Target="../media/image6.png"/><Relationship Id="rId4" Type="http://schemas.openxmlformats.org/officeDocument/2006/relationships/image" Target="../media/image5.png"/></Relationships>
</file>

<file path=ppt/slides/_rels/slide3.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AutoShape 4">
            <a:extLst>
              <a:ext uri="{FF2B5EF4-FFF2-40B4-BE49-F238E27FC236}">
                <a16:creationId xmlns:a16="http://schemas.microsoft.com/office/drawing/2014/main" id="{7D8B8E84-2EB0-4E8A-15A8-DD214E343147}"/>
              </a:ext>
            </a:extLst>
          </p:cNvPr>
          <p:cNvSpPr>
            <a:spLocks noChangeAspect="1" noChangeArrowheads="1"/>
          </p:cNvSpPr>
          <p:nvPr/>
        </p:nvSpPr>
        <p:spPr bwMode="auto">
          <a:xfrm>
            <a:off x="5905240" y="4119983"/>
            <a:ext cx="406400" cy="406400"/>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121920" tIns="60960" rIns="121920" bIns="60960" numCol="1" anchor="t" anchorCtr="0" compatLnSpc="1">
            <a:prstTxWarp prst="textNoShape">
              <a:avLst/>
            </a:prstTxWarp>
          </a:bodyPr>
          <a:lstStyle/>
          <a:p>
            <a:endParaRPr lang="en-US" sz="2400"/>
          </a:p>
        </p:txBody>
      </p:sp>
      <p:sp>
        <p:nvSpPr>
          <p:cNvPr id="19" name="TextBox 18">
            <a:extLst>
              <a:ext uri="{FF2B5EF4-FFF2-40B4-BE49-F238E27FC236}">
                <a16:creationId xmlns:a16="http://schemas.microsoft.com/office/drawing/2014/main" id="{8647C4DA-ABF3-1B74-8C36-5E500B94E9AC}"/>
              </a:ext>
            </a:extLst>
          </p:cNvPr>
          <p:cNvSpPr txBox="1"/>
          <p:nvPr/>
        </p:nvSpPr>
        <p:spPr>
          <a:xfrm>
            <a:off x="891367" y="404041"/>
            <a:ext cx="9262035" cy="400110"/>
          </a:xfrm>
          <a:prstGeom prst="rect">
            <a:avLst/>
          </a:prstGeom>
          <a:noFill/>
        </p:spPr>
        <p:txBody>
          <a:bodyPr wrap="square" rtlCol="0">
            <a:spAutoFit/>
          </a:bodyPr>
          <a:lstStyle/>
          <a:p>
            <a:r>
              <a:rPr lang="en-US" sz="2000" b="1" dirty="0">
                <a:latin typeface="Times New Roman" panose="02020603050405020304" pitchFamily="18" charset="0"/>
                <a:cs typeface="Times New Roman" panose="02020603050405020304" pitchFamily="18" charset="0"/>
              </a:rPr>
              <a:t>Supplemental Figure 1: Smoothed terms of 2 separate generalized additive models. </a:t>
            </a:r>
          </a:p>
        </p:txBody>
      </p:sp>
      <p:sp>
        <p:nvSpPr>
          <p:cNvPr id="2" name="TextBox 1">
            <a:extLst>
              <a:ext uri="{FF2B5EF4-FFF2-40B4-BE49-F238E27FC236}">
                <a16:creationId xmlns:a16="http://schemas.microsoft.com/office/drawing/2014/main" id="{5CABF5F6-98EC-6F97-42CA-B7446989C909}"/>
              </a:ext>
            </a:extLst>
          </p:cNvPr>
          <p:cNvSpPr txBox="1"/>
          <p:nvPr/>
        </p:nvSpPr>
        <p:spPr>
          <a:xfrm>
            <a:off x="1238246" y="4746992"/>
            <a:ext cx="8798650" cy="1169551"/>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Supplemental Figure 1 shows the smoothed terms of annual PM2·5 from two separate generalized additive models, with outcomes of respiratory infection in the past 2 weeks (left panel), and </a:t>
            </a:r>
            <a:r>
              <a:rPr lang="en-US" sz="1400" dirty="0" err="1">
                <a:latin typeface="Times New Roman" panose="02020603050405020304" pitchFamily="18" charset="0"/>
                <a:cs typeface="Times New Roman" panose="02020603050405020304" pitchFamily="18" charset="0"/>
              </a:rPr>
              <a:t>anaemia</a:t>
            </a:r>
            <a:r>
              <a:rPr lang="en-US" sz="1400" dirty="0">
                <a:latin typeface="Times New Roman" panose="02020603050405020304" pitchFamily="18" charset="0"/>
                <a:cs typeface="Times New Roman" panose="02020603050405020304" pitchFamily="18" charset="0"/>
              </a:rPr>
              <a:t> (right panel). The graphs represent the non-linear effect of annual PM2·5 on the probability of severe respiratory infections and </a:t>
            </a:r>
            <a:r>
              <a:rPr lang="en-US" sz="1400" dirty="0" err="1">
                <a:latin typeface="Times New Roman" panose="02020603050405020304" pitchFamily="18" charset="0"/>
                <a:cs typeface="Times New Roman" panose="02020603050405020304" pitchFamily="18" charset="0"/>
              </a:rPr>
              <a:t>anaemia</a:t>
            </a:r>
            <a:r>
              <a:rPr lang="en-US" sz="1400" dirty="0">
                <a:latin typeface="Times New Roman" panose="02020603050405020304" pitchFamily="18" charset="0"/>
                <a:cs typeface="Times New Roman" panose="02020603050405020304" pitchFamily="18" charset="0"/>
              </a:rPr>
              <a:t>, respectively. Note that for the respiratory infection model, we observe an increasing effect of annual PM2·5, whereas this effect is not observed for the </a:t>
            </a:r>
            <a:r>
              <a:rPr lang="en-US" sz="1400" dirty="0" err="1">
                <a:latin typeface="Times New Roman" panose="02020603050405020304" pitchFamily="18" charset="0"/>
                <a:cs typeface="Times New Roman" panose="02020603050405020304" pitchFamily="18" charset="0"/>
              </a:rPr>
              <a:t>anaemia</a:t>
            </a:r>
            <a:r>
              <a:rPr lang="en-US" sz="1400" dirty="0">
                <a:latin typeface="Times New Roman" panose="02020603050405020304" pitchFamily="18" charset="0"/>
                <a:cs typeface="Times New Roman" panose="02020603050405020304" pitchFamily="18" charset="0"/>
              </a:rPr>
              <a:t> model. Dashed vertical line indicates Indian standard of 40 µg/m3. </a:t>
            </a:r>
          </a:p>
        </p:txBody>
      </p:sp>
      <p:pic>
        <p:nvPicPr>
          <p:cNvPr id="5" name="Picture 4" descr="A graph of a graph showing the amount of oxygen in the body&#10;&#10;Description automatically generated with medium confidence">
            <a:extLst>
              <a:ext uri="{FF2B5EF4-FFF2-40B4-BE49-F238E27FC236}">
                <a16:creationId xmlns:a16="http://schemas.microsoft.com/office/drawing/2014/main" id="{76444A93-F959-4EE8-6D63-DCF6984B75F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563825" y="1196602"/>
            <a:ext cx="4114808" cy="3200407"/>
          </a:xfrm>
          <a:prstGeom prst="rect">
            <a:avLst/>
          </a:prstGeom>
        </p:spPr>
      </p:pic>
      <p:pic>
        <p:nvPicPr>
          <p:cNvPr id="8" name="Picture 7" descr="A graph of respiratory infection model&#10;&#10;Description automatically generated">
            <a:extLst>
              <a:ext uri="{FF2B5EF4-FFF2-40B4-BE49-F238E27FC236}">
                <a16:creationId xmlns:a16="http://schemas.microsoft.com/office/drawing/2014/main" id="{96F58E11-4C16-5F7E-2BBE-4F7D9826A25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238246" y="1196602"/>
            <a:ext cx="4114808" cy="3200407"/>
          </a:xfrm>
          <a:prstGeom prst="rect">
            <a:avLst/>
          </a:prstGeom>
        </p:spPr>
      </p:pic>
    </p:spTree>
    <p:extLst>
      <p:ext uri="{BB962C8B-B14F-4D97-AF65-F5344CB8AC3E}">
        <p14:creationId xmlns:p14="http://schemas.microsoft.com/office/powerpoint/2010/main" val="51525751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1" name="Picture 30" descr="A graph of a line graph&#10;&#10;Description automatically generated with medium confidence">
            <a:extLst>
              <a:ext uri="{FF2B5EF4-FFF2-40B4-BE49-F238E27FC236}">
                <a16:creationId xmlns:a16="http://schemas.microsoft.com/office/drawing/2014/main" id="{C1D799F0-3C97-587F-0581-D5A0F941373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6590" y="3937199"/>
            <a:ext cx="4114808" cy="3200407"/>
          </a:xfrm>
          <a:prstGeom prst="rect">
            <a:avLst/>
          </a:prstGeom>
        </p:spPr>
      </p:pic>
      <p:sp>
        <p:nvSpPr>
          <p:cNvPr id="19" name="TextBox 18">
            <a:extLst>
              <a:ext uri="{FF2B5EF4-FFF2-40B4-BE49-F238E27FC236}">
                <a16:creationId xmlns:a16="http://schemas.microsoft.com/office/drawing/2014/main" id="{8647C4DA-ABF3-1B74-8C36-5E500B94E9AC}"/>
              </a:ext>
            </a:extLst>
          </p:cNvPr>
          <p:cNvSpPr txBox="1"/>
          <p:nvPr/>
        </p:nvSpPr>
        <p:spPr>
          <a:xfrm>
            <a:off x="1106346" y="308525"/>
            <a:ext cx="8904553" cy="400110"/>
          </a:xfrm>
          <a:prstGeom prst="rect">
            <a:avLst/>
          </a:prstGeom>
          <a:noFill/>
        </p:spPr>
        <p:txBody>
          <a:bodyPr wrap="square" rtlCol="0">
            <a:spAutoFit/>
          </a:bodyPr>
          <a:lstStyle/>
          <a:p>
            <a:r>
              <a:rPr lang="en-US" sz="2000" b="1" dirty="0">
                <a:latin typeface="Times New Roman" panose="02020603050405020304" pitchFamily="18" charset="0"/>
                <a:cs typeface="Times New Roman" panose="02020603050405020304" pitchFamily="18" charset="0"/>
              </a:rPr>
              <a:t>Supplemental Figure 2: Smoothed terms of stratified analyses, by region. </a:t>
            </a:r>
          </a:p>
        </p:txBody>
      </p:sp>
      <p:sp>
        <p:nvSpPr>
          <p:cNvPr id="2" name="TextBox 1">
            <a:extLst>
              <a:ext uri="{FF2B5EF4-FFF2-40B4-BE49-F238E27FC236}">
                <a16:creationId xmlns:a16="http://schemas.microsoft.com/office/drawing/2014/main" id="{5CABF5F6-98EC-6F97-42CA-B7446989C909}"/>
              </a:ext>
            </a:extLst>
          </p:cNvPr>
          <p:cNvSpPr txBox="1"/>
          <p:nvPr/>
        </p:nvSpPr>
        <p:spPr>
          <a:xfrm>
            <a:off x="71252" y="7391396"/>
            <a:ext cx="11696348" cy="1569660"/>
          </a:xfrm>
          <a:prstGeom prst="rect">
            <a:avLst/>
          </a:prstGeom>
          <a:noFill/>
        </p:spPr>
        <p:txBody>
          <a:bodyPr wrap="square" rtlCol="0">
            <a:spAutoFit/>
          </a:bodyPr>
          <a:lstStyle/>
          <a:p>
            <a:r>
              <a:rPr lang="en-US" sz="1200" dirty="0">
                <a:latin typeface="Times New Roman" panose="02020603050405020304" pitchFamily="18" charset="0"/>
                <a:cs typeface="Times New Roman" panose="02020603050405020304" pitchFamily="18" charset="0"/>
              </a:rPr>
              <a:t>Supplemental Figure 2 shows the smoothed terms of annual PM2·5 levels (µg/m3) from our stratified analyses, in which we stratify the sample by region of India. Each term comes from a separate generalized additive model, with outcome of severe respiratory infection. The graphs represent the non-linear effect of annual PM2·5 on the probability of severe respiratory infections. Note that a steeper slope indicates a stronger effect, and the grey bands indicate 95% confidence intervals. The Northern region: Chandigarh, Haryana, Himachal Pradesh, Jammu &amp; Kashmir, Ladakh, Delhi, Punjab, Rajasthan, and Uttarakhand; Central region: Chhattisgarh, Madhya Pradesh, and Uttar Pradesh; Eastern region Bihar, Jharkhand, Odisha, and West Bengal; Northeast region: Arunachal Pradesh, Assam, Manipur, Meghalaya, Mizoram, Nagaland, Sikkim, and Tripura; Western region: Dadra &amp; Nagar Haveli, Daman &amp; Diu, Goa, Gujarat, and Maharashtra; the Southern region: Andaman &amp; Nicobar Islands, Andhra Pradesh, Karnataka, Kerala, Puducherry, Tamil Nadu, and Telangana. Note that the West region does not see the same impact of PM2·5 levels , as compared to the other regions, which is an area that warrants confirmation in other study settings and, if confirmed, further investigation as to why children living in this region might not be as affected as children in other regions. Dashed vertical line indicates Indian standard of 40 µg/m3. </a:t>
            </a:r>
          </a:p>
        </p:txBody>
      </p:sp>
      <p:pic>
        <p:nvPicPr>
          <p:cNvPr id="15" name="Picture 14" descr="A graph of a number of people&#10;&#10;Description automatically generated with medium confidence">
            <a:extLst>
              <a:ext uri="{FF2B5EF4-FFF2-40B4-BE49-F238E27FC236}">
                <a16:creationId xmlns:a16="http://schemas.microsoft.com/office/drawing/2014/main" id="{FB3DF726-F3D5-C849-F6AD-7F9439D25A50}"/>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114808" y="775794"/>
            <a:ext cx="4114808" cy="3200407"/>
          </a:xfrm>
          <a:prstGeom prst="rect">
            <a:avLst/>
          </a:prstGeom>
        </p:spPr>
      </p:pic>
      <p:pic>
        <p:nvPicPr>
          <p:cNvPr id="17" name="Picture 16" descr="A graph of a number of regions&#10;&#10;Description automatically generated with medium confidence">
            <a:extLst>
              <a:ext uri="{FF2B5EF4-FFF2-40B4-BE49-F238E27FC236}">
                <a16:creationId xmlns:a16="http://schemas.microsoft.com/office/drawing/2014/main" id="{2391D657-4190-25BA-345A-825DD466F0EB}"/>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986585" y="3937199"/>
            <a:ext cx="4114808" cy="3200407"/>
          </a:xfrm>
          <a:prstGeom prst="rect">
            <a:avLst/>
          </a:prstGeom>
        </p:spPr>
      </p:pic>
      <p:pic>
        <p:nvPicPr>
          <p:cNvPr id="21" name="Picture 20" descr="A graph of a number of pm2. 5&#10;&#10;Description automatically generated">
            <a:extLst>
              <a:ext uri="{FF2B5EF4-FFF2-40B4-BE49-F238E27FC236}">
                <a16:creationId xmlns:a16="http://schemas.microsoft.com/office/drawing/2014/main" id="{FC9A5426-D1B1-7314-5FDE-D5D12F173F2D}"/>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71252" y="736793"/>
            <a:ext cx="4114808" cy="3200407"/>
          </a:xfrm>
          <a:prstGeom prst="rect">
            <a:avLst/>
          </a:prstGeom>
        </p:spPr>
      </p:pic>
      <p:pic>
        <p:nvPicPr>
          <p:cNvPr id="25" name="Picture 24" descr="A graph of a number of regions&#10;&#10;Description automatically generated with medium confidence">
            <a:extLst>
              <a:ext uri="{FF2B5EF4-FFF2-40B4-BE49-F238E27FC236}">
                <a16:creationId xmlns:a16="http://schemas.microsoft.com/office/drawing/2014/main" id="{566CBEDC-100E-FF3F-D4F0-8465D6AEFC1E}"/>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7981923" y="756293"/>
            <a:ext cx="4114808" cy="3200407"/>
          </a:xfrm>
          <a:prstGeom prst="rect">
            <a:avLst/>
          </a:prstGeom>
        </p:spPr>
      </p:pic>
      <p:pic>
        <p:nvPicPr>
          <p:cNvPr id="29" name="Picture 28" descr="A graph of a graph showing the growth of the region&#10;&#10;Description automatically generated with medium confidence">
            <a:extLst>
              <a:ext uri="{FF2B5EF4-FFF2-40B4-BE49-F238E27FC236}">
                <a16:creationId xmlns:a16="http://schemas.microsoft.com/office/drawing/2014/main" id="{1069D36F-B9B2-E6E0-EF98-EED521FC749C}"/>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4043556" y="3937200"/>
            <a:ext cx="4114808" cy="3200407"/>
          </a:xfrm>
          <a:prstGeom prst="rect">
            <a:avLst/>
          </a:prstGeom>
        </p:spPr>
      </p:pic>
    </p:spTree>
    <p:extLst>
      <p:ext uri="{BB962C8B-B14F-4D97-AF65-F5344CB8AC3E}">
        <p14:creationId xmlns:p14="http://schemas.microsoft.com/office/powerpoint/2010/main" val="374495716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AutoShape 4">
            <a:extLst>
              <a:ext uri="{FF2B5EF4-FFF2-40B4-BE49-F238E27FC236}">
                <a16:creationId xmlns:a16="http://schemas.microsoft.com/office/drawing/2014/main" id="{7D8B8E84-2EB0-4E8A-15A8-DD214E343147}"/>
              </a:ext>
            </a:extLst>
          </p:cNvPr>
          <p:cNvSpPr>
            <a:spLocks noChangeAspect="1" noChangeArrowheads="1"/>
          </p:cNvSpPr>
          <p:nvPr/>
        </p:nvSpPr>
        <p:spPr bwMode="auto">
          <a:xfrm>
            <a:off x="5905240" y="4119983"/>
            <a:ext cx="406400" cy="406400"/>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121920" tIns="60960" rIns="121920" bIns="60960" numCol="1" anchor="t" anchorCtr="0" compatLnSpc="1">
            <a:prstTxWarp prst="textNoShape">
              <a:avLst/>
            </a:prstTxWarp>
          </a:bodyPr>
          <a:lstStyle/>
          <a:p>
            <a:endParaRPr lang="en-US" sz="2400"/>
          </a:p>
        </p:txBody>
      </p:sp>
      <p:sp>
        <p:nvSpPr>
          <p:cNvPr id="19" name="TextBox 18">
            <a:extLst>
              <a:ext uri="{FF2B5EF4-FFF2-40B4-BE49-F238E27FC236}">
                <a16:creationId xmlns:a16="http://schemas.microsoft.com/office/drawing/2014/main" id="{8647C4DA-ABF3-1B74-8C36-5E500B94E9AC}"/>
              </a:ext>
            </a:extLst>
          </p:cNvPr>
          <p:cNvSpPr txBox="1"/>
          <p:nvPr/>
        </p:nvSpPr>
        <p:spPr>
          <a:xfrm>
            <a:off x="944940" y="937464"/>
            <a:ext cx="6958943" cy="400110"/>
          </a:xfrm>
          <a:prstGeom prst="rect">
            <a:avLst/>
          </a:prstGeom>
          <a:noFill/>
        </p:spPr>
        <p:txBody>
          <a:bodyPr wrap="square" rtlCol="0">
            <a:spAutoFit/>
          </a:bodyPr>
          <a:lstStyle/>
          <a:p>
            <a:pPr algn="ctr"/>
            <a:r>
              <a:rPr lang="en-US" sz="2000" b="1" dirty="0">
                <a:latin typeface="Times New Roman" panose="02020603050405020304" pitchFamily="18" charset="0"/>
                <a:cs typeface="Times New Roman" panose="02020603050405020304" pitchFamily="18" charset="0"/>
              </a:rPr>
              <a:t>Supplemental Figure 3: Smoothed terms of weighted analysis. </a:t>
            </a:r>
          </a:p>
        </p:txBody>
      </p:sp>
      <p:sp>
        <p:nvSpPr>
          <p:cNvPr id="2" name="TextBox 1">
            <a:extLst>
              <a:ext uri="{FF2B5EF4-FFF2-40B4-BE49-F238E27FC236}">
                <a16:creationId xmlns:a16="http://schemas.microsoft.com/office/drawing/2014/main" id="{5CABF5F6-98EC-6F97-42CA-B7446989C909}"/>
              </a:ext>
            </a:extLst>
          </p:cNvPr>
          <p:cNvSpPr txBox="1"/>
          <p:nvPr/>
        </p:nvSpPr>
        <p:spPr>
          <a:xfrm>
            <a:off x="962324" y="4979177"/>
            <a:ext cx="7837292" cy="1092607"/>
          </a:xfrm>
          <a:prstGeom prst="rect">
            <a:avLst/>
          </a:prstGeom>
          <a:noFill/>
        </p:spPr>
        <p:txBody>
          <a:bodyPr wrap="square" rtlCol="0">
            <a:spAutoFit/>
          </a:bodyPr>
          <a:lstStyle/>
          <a:p>
            <a:r>
              <a:rPr lang="en-US" sz="1300" dirty="0">
                <a:latin typeface="Times New Roman" panose="02020603050405020304" pitchFamily="18" charset="0"/>
                <a:cs typeface="Times New Roman" panose="02020603050405020304" pitchFamily="18" charset="0"/>
              </a:rPr>
              <a:t>Supplemental Figure 3 shows the smoothed terms of annual PM2·5 levels (left) and mean temperature month of interview (right) from the generalized additive model that includes survey weights, with outcome of reported respiratory infection. The graphs represent the non-linear effect of annual PM2·5 and temperature on the probability of respiratory infections. Note these graphs have essentially the same shapes as the non-weighted analysis (Figure 3). Dashed vertical line indicates Indian annual PM2·5 standard of 40 µg/m3.  </a:t>
            </a:r>
          </a:p>
        </p:txBody>
      </p:sp>
      <p:pic>
        <p:nvPicPr>
          <p:cNvPr id="4" name="Picture 3" descr="A graph of respiratory infection model&#10;&#10;Description automatically generated">
            <a:extLst>
              <a:ext uri="{FF2B5EF4-FFF2-40B4-BE49-F238E27FC236}">
                <a16:creationId xmlns:a16="http://schemas.microsoft.com/office/drawing/2014/main" id="{3A3A974E-EEE5-47EF-AEFC-3CD652E63D2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19819" y="1618009"/>
            <a:ext cx="4114808" cy="3200407"/>
          </a:xfrm>
          <a:prstGeom prst="rect">
            <a:avLst/>
          </a:prstGeom>
        </p:spPr>
      </p:pic>
      <p:pic>
        <p:nvPicPr>
          <p:cNvPr id="9" name="Picture 8" descr="A graph of a respiratory infection model&#10;&#10;Description automatically generated">
            <a:extLst>
              <a:ext uri="{FF2B5EF4-FFF2-40B4-BE49-F238E27FC236}">
                <a16:creationId xmlns:a16="http://schemas.microsoft.com/office/drawing/2014/main" id="{35262679-9CB6-F31D-DC66-344EF2F3D77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039096" y="1618009"/>
            <a:ext cx="4114808" cy="3200407"/>
          </a:xfrm>
          <a:prstGeom prst="rect">
            <a:avLst/>
          </a:prstGeom>
        </p:spPr>
      </p:pic>
    </p:spTree>
    <p:extLst>
      <p:ext uri="{BB962C8B-B14F-4D97-AF65-F5344CB8AC3E}">
        <p14:creationId xmlns:p14="http://schemas.microsoft.com/office/powerpoint/2010/main" val="263982579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880</TotalTime>
  <Words>493</Words>
  <Application>Microsoft Office PowerPoint</Application>
  <PresentationFormat>Custom</PresentationFormat>
  <Paragraphs>6</Paragraphs>
  <Slides>3</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rial</vt:lpstr>
      <vt:lpstr>Calibri</vt:lpstr>
      <vt:lpstr>Calibri Light</vt:lpstr>
      <vt:lpstr>Times New Roman</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eorge, Paul</dc:creator>
  <cp:lastModifiedBy>George, Paul</cp:lastModifiedBy>
  <cp:revision>5</cp:revision>
  <dcterms:created xsi:type="dcterms:W3CDTF">2023-03-11T01:32:41Z</dcterms:created>
  <dcterms:modified xsi:type="dcterms:W3CDTF">2023-09-26T18:06:24Z</dcterms:modified>
</cp:coreProperties>
</file>